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854"/>
    <p:restoredTop sz="94632" autoAdjust="0"/>
  </p:normalViewPr>
  <p:slideViewPr>
    <p:cSldViewPr snapToGrid="0">
      <p:cViewPr>
        <p:scale>
          <a:sx n="127" d="100"/>
          <a:sy n="127" d="100"/>
        </p:scale>
        <p:origin x="379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BFA1E3-3443-42E7-B399-F5A01FCC8320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4AF26-6E68-41A3-8E50-A1B38F26CD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480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64AF26-6E68-41A3-8E50-A1B38F26CD0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4578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061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334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507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340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46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248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995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539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110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86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093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8842AC-8E33-AB44-80BB-813608DD1E74}" type="datetimeFigureOut">
              <a:rPr lang="en-US" smtClean="0"/>
              <a:t>1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B4BAB-F647-D440-9DC7-263D0B61D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666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6873E83B-90AD-5F7F-F577-C7BB2010B9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4969" y="3212949"/>
            <a:ext cx="2375828" cy="279191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CA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eligible (n = 37)</a:t>
            </a:r>
            <a:endParaRPr lang="en-US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eligible PASS/PCS (n=21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thopedic injury outside 2-month window (n=7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ronic pain (n=6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jured in multiple locations (n=2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urrent or prior diagnosis of epilepsy, seizure disorder, dementia, migraines, etc. (n=1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dical condition predisposing to nausea or dizziness (n=2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t willing to comply with requirements of protocol (n=4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jury to eyes, face, or neck that impedes comfortable use of VR (n=1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actice of meditation/mind-body techniques (n=1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der litigation/Workman’s Comp (n=1)</a:t>
            </a:r>
          </a:p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endParaRPr lang="en-US" sz="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NOTE: participants can screen ineligible for multiple reasons.</a:t>
            </a:r>
            <a:endParaRPr lang="en-US" sz="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AutoShape 26">
            <a:extLst>
              <a:ext uri="{FF2B5EF4-FFF2-40B4-BE49-F238E27FC236}">
                <a16:creationId xmlns:a16="http://schemas.microsoft.com/office/drawing/2014/main" id="{359B81BE-73EA-647C-1433-6698F07AD8C7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016213" y="4611205"/>
            <a:ext cx="1258756" cy="259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42" name="Rectangle 41">
            <a:extLst>
              <a:ext uri="{FF2B5EF4-FFF2-40B4-BE49-F238E27FC236}">
                <a16:creationId xmlns:a16="http://schemas.microsoft.com/office/drawing/2014/main" id="{B1E866AA-DC89-4D8E-49E8-42681F7CF2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1479" y="366582"/>
            <a:ext cx="2109470" cy="37528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CA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itial Inquiry Received (n = 109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43" name="AutoShape 9">
            <a:extLst>
              <a:ext uri="{FF2B5EF4-FFF2-40B4-BE49-F238E27FC236}">
                <a16:creationId xmlns:a16="http://schemas.microsoft.com/office/drawing/2014/main" id="{C93A63CF-8D2D-BE2D-AFDC-5EB113F38D76}"/>
              </a:ext>
            </a:extLst>
          </p:cNvPr>
          <p:cNvCxnSpPr>
            <a:cxnSpLocks noChangeShapeType="1"/>
            <a:stCxn id="42" idx="2"/>
          </p:cNvCxnSpPr>
          <p:nvPr/>
        </p:nvCxnSpPr>
        <p:spPr bwMode="auto">
          <a:xfrm>
            <a:off x="2016214" y="741867"/>
            <a:ext cx="0" cy="7902483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D878DD8D-7DB1-19D1-CD42-D2AECEE53C56}"/>
              </a:ext>
            </a:extLst>
          </p:cNvPr>
          <p:cNvSpPr/>
          <p:nvPr/>
        </p:nvSpPr>
        <p:spPr>
          <a:xfrm>
            <a:off x="824669" y="2537322"/>
            <a:ext cx="2328269" cy="53619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ompleted Screening (n = 49)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2B7BDD3-0365-0B02-2355-D828682662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1477" y="6091675"/>
            <a:ext cx="2054651" cy="36385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CA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ligible (n = 12)</a:t>
            </a:r>
            <a:endParaRPr lang="en-US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97BA26F-F298-7FAC-1106-D7EBD73B88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767" y="8647599"/>
            <a:ext cx="2569434" cy="30930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CA" sz="8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leted post-tests and exit interview </a:t>
            </a:r>
            <a:r>
              <a:rPr lang="en-CA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n = 10)</a:t>
            </a:r>
            <a:endParaRPr lang="en-CA" sz="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49" name="AutoShape 26">
            <a:extLst>
              <a:ext uri="{FF2B5EF4-FFF2-40B4-BE49-F238E27FC236}">
                <a16:creationId xmlns:a16="http://schemas.microsoft.com/office/drawing/2014/main" id="{D98B4937-16C8-7908-678D-049E15C01434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016213" y="6721390"/>
            <a:ext cx="1258756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3C81C43E-D5F5-A0D7-857A-FF9412DD2C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4969" y="6505365"/>
            <a:ext cx="2337844" cy="45300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>
              <a:lnSpc>
                <a:spcPct val="107000"/>
              </a:lnSpc>
            </a:pPr>
            <a:r>
              <a:rPr lang="en-US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t enrolled (n=2)</a:t>
            </a:r>
          </a:p>
          <a:p>
            <a:pPr marL="171450" indent="-171450">
              <a:lnSpc>
                <a:spcPct val="107000"/>
              </a:lnSpc>
              <a:buFont typeface="Arial" panose="020B0604020202020204" pitchFamily="34" charset="0"/>
              <a:buChar char="•"/>
            </a:pP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ssively withdrew (n = 2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43A2CC8-A5F5-8D35-B4E2-59EA172A74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2947" y="1932945"/>
            <a:ext cx="2632958" cy="5241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t screened (n = 41)</a:t>
            </a:r>
            <a:endParaRPr lang="en-US" sz="8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clined or withdrew consent to screening (n=26)</a:t>
            </a:r>
          </a:p>
          <a:p>
            <a:pPr marL="171450" marR="0" lvl="0" indent="-17145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covered ineligible prior to screening (n=15)</a:t>
            </a:r>
          </a:p>
        </p:txBody>
      </p:sp>
      <p:cxnSp>
        <p:nvCxnSpPr>
          <p:cNvPr id="34" name="AutoShape 26">
            <a:extLst>
              <a:ext uri="{FF2B5EF4-FFF2-40B4-BE49-F238E27FC236}">
                <a16:creationId xmlns:a16="http://schemas.microsoft.com/office/drawing/2014/main" id="{4CECC9B9-F0A5-F0AD-1296-F823E1AB5C88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016213" y="1009702"/>
            <a:ext cx="1256081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0A12CC71-7948-2DC7-CB6C-44767EDE7F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2947" y="858704"/>
            <a:ext cx="1428104" cy="2853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able to contact (n = 19) </a:t>
            </a:r>
          </a:p>
        </p:txBody>
      </p:sp>
      <p:cxnSp>
        <p:nvCxnSpPr>
          <p:cNvPr id="5" name="AutoShape 26">
            <a:extLst>
              <a:ext uri="{FF2B5EF4-FFF2-40B4-BE49-F238E27FC236}">
                <a16:creationId xmlns:a16="http://schemas.microsoft.com/office/drawing/2014/main" id="{938822F9-78DB-F13F-151E-7E2479A88EEF}"/>
              </a:ext>
            </a:extLst>
          </p:cNvPr>
          <p:cNvCxnSpPr>
            <a:cxnSpLocks noChangeShapeType="1"/>
            <a:endCxn id="32" idx="1"/>
          </p:cNvCxnSpPr>
          <p:nvPr/>
        </p:nvCxnSpPr>
        <p:spPr bwMode="auto">
          <a:xfrm>
            <a:off x="2016213" y="2195023"/>
            <a:ext cx="1256734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8D4D49D5-1B48-D5B1-BB73-394AF2DDD9D9}"/>
              </a:ext>
            </a:extLst>
          </p:cNvPr>
          <p:cNvSpPr/>
          <p:nvPr/>
        </p:nvSpPr>
        <p:spPr>
          <a:xfrm>
            <a:off x="748767" y="1271791"/>
            <a:ext cx="2328269" cy="53619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pproached and Contacted (n = 90) 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7E54ED3-DA7D-4FC6-B59F-6A7B821816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6058" y="7128985"/>
            <a:ext cx="1845490" cy="35049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leted baseline (n=10)</a:t>
            </a:r>
            <a:endParaRPr lang="en-CA" sz="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endParaRPr lang="en-US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D0C3FC7-27E3-5AAB-6030-68621A5EE8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6058" y="7849316"/>
            <a:ext cx="1871203" cy="35049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leted intervention (n = 10)</a:t>
            </a:r>
          </a:p>
        </p:txBody>
      </p:sp>
    </p:spTree>
    <p:extLst>
      <p:ext uri="{BB962C8B-B14F-4D97-AF65-F5344CB8AC3E}">
        <p14:creationId xmlns:p14="http://schemas.microsoft.com/office/powerpoint/2010/main" val="2124040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6</TotalTime>
  <Words>243</Words>
  <Application>Microsoft Macintosh PowerPoint</Application>
  <PresentationFormat>Custom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Brewer</dc:creator>
  <cp:lastModifiedBy>Mace, Ryan Andrew</cp:lastModifiedBy>
  <cp:revision>85</cp:revision>
  <dcterms:created xsi:type="dcterms:W3CDTF">2022-09-27T19:31:54Z</dcterms:created>
  <dcterms:modified xsi:type="dcterms:W3CDTF">2023-12-28T16:50:24Z</dcterms:modified>
</cp:coreProperties>
</file>